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3" r:id="rId3"/>
    <p:sldId id="264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680"/>
  </p:normalViewPr>
  <p:slideViewPr>
    <p:cSldViewPr snapToGrid="0">
      <p:cViewPr varScale="1">
        <p:scale>
          <a:sx n="122" d="100"/>
          <a:sy n="122" d="100"/>
        </p:scale>
        <p:origin x="114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6AA2D7-319B-D35D-0281-6CD5467B6E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6D04673-5530-ECD9-CEE6-A6F3F262D8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19280B-6A47-AE75-58D3-CA88D642FC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654E-F97B-134A-8220-F87DA4D60CCC}" type="datetimeFigureOut">
              <a:rPr lang="en-US" smtClean="0"/>
              <a:t>6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FC57E7-2A4E-7B63-C771-C785DF71F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C55F22-57F1-983B-5B5F-247D18F19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7F758-F823-3B40-BCD8-0FE5D4CC50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7817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C945D3-D9BC-C224-66C9-7E072DBFE7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5D6ECE-CAF3-8726-FCA2-99CE874A9C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4AE94C-2901-E490-3519-DB2672CC7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654E-F97B-134A-8220-F87DA4D60CCC}" type="datetimeFigureOut">
              <a:rPr lang="en-US" smtClean="0"/>
              <a:t>6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395D2D-DC8E-1055-C4D7-1B9470DAC1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839FD7-EF31-7C99-49F5-16C306AC4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7F758-F823-3B40-BCD8-0FE5D4CC50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580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6F0A6D-ECF2-C318-B3AD-73E5FBE7C6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6F51A5-161A-82E3-9A4B-A77CDDA45A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DA8A24-7E95-6648-BC98-5128B11DC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654E-F97B-134A-8220-F87DA4D60CCC}" type="datetimeFigureOut">
              <a:rPr lang="en-US" smtClean="0"/>
              <a:t>6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3A9E08-08BE-45D9-EE22-C537D69AF0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62C321-C068-B94B-995E-BB7AB9751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7F758-F823-3B40-BCD8-0FE5D4CC50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761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EEB704-D88D-D3BB-3F7E-95EF39E5FE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CD0A04-7FB2-C9F5-DD67-D8AC797488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55D48D-02B8-5639-A072-7CF4464692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654E-F97B-134A-8220-F87DA4D60CCC}" type="datetimeFigureOut">
              <a:rPr lang="en-US" smtClean="0"/>
              <a:t>6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F38230-8C54-CCE1-35E1-2D5673FED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5EC072-D480-7985-63EB-18CD93905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7F758-F823-3B40-BCD8-0FE5D4CC50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084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3ED29E-FFC9-22A0-3892-C4595EF484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7EC41A-6199-EDEC-382D-57C9D67971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6CB2AD-8E60-7294-CB06-8C04628B3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654E-F97B-134A-8220-F87DA4D60CCC}" type="datetimeFigureOut">
              <a:rPr lang="en-US" smtClean="0"/>
              <a:t>6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485124-19A8-B5C5-5191-149237B248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B7732E-D947-DD4B-E2DF-54272F2F13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7F758-F823-3B40-BCD8-0FE5D4CC50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503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38F094-9FFC-FFB7-9999-38A8459E5D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EAA9D9-5C27-CBF4-22C3-4E7876C11C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69152B-7AC3-C3A0-B18B-7E2C1B7682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7D9FBD-B693-39A3-498D-BA1560DC55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654E-F97B-134A-8220-F87DA4D60CCC}" type="datetimeFigureOut">
              <a:rPr lang="en-US" smtClean="0"/>
              <a:t>6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62F3E9-1362-5D67-8EB0-B641692F50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5D1B4E-5BA1-09BD-9931-8AD8C046DF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7F758-F823-3B40-BCD8-0FE5D4CC50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423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EE90F5-7AE2-BD04-68B3-0639E200BA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D27265-BC83-D9C7-D082-28FEAA07B2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D95B9D-EE4A-8DDB-CA78-316329BB79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F687CB7-87EA-FB2D-FBF1-5C770B59E1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E55B7A-61C1-FBBE-042C-04CD38305A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7EA8A3-4F38-66D6-E054-B50A2C04AA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654E-F97B-134A-8220-F87DA4D60CCC}" type="datetimeFigureOut">
              <a:rPr lang="en-US" smtClean="0"/>
              <a:t>6/2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9997F63-3653-D02D-AAE2-AEF81302DE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069842-3F41-A667-E87A-F66D65121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7F758-F823-3B40-BCD8-0FE5D4CC50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452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118C07-D981-AD6F-45FB-14C4CB7BAE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C6C0256-1DB0-AE0A-24E4-6724D96B81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654E-F97B-134A-8220-F87DA4D60CCC}" type="datetimeFigureOut">
              <a:rPr lang="en-US" smtClean="0"/>
              <a:t>6/2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3AEFF3A-03D1-E1FD-F859-24126F8E37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7226F67-4054-1D06-48ED-9105866D2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7F758-F823-3B40-BCD8-0FE5D4CC50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80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322CAE-D282-00CA-2A6C-B9111E097A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654E-F97B-134A-8220-F87DA4D60CCC}" type="datetimeFigureOut">
              <a:rPr lang="en-US" smtClean="0"/>
              <a:t>6/2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AB36465-B473-5009-2CCE-C6F25EFB52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80F3D0-4A9D-0380-40B1-1EFF5A5877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7F758-F823-3B40-BCD8-0FE5D4CC50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937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5132FA-7030-6BEA-D7EF-F74A4ADB5B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88CA82-C873-5C5E-E55C-0CCA35CB32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4C7107-1F08-51AE-121E-BEB0171BCC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3D5B5C-6090-FB50-5E0E-841E5117AD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654E-F97B-134A-8220-F87DA4D60CCC}" type="datetimeFigureOut">
              <a:rPr lang="en-US" smtClean="0"/>
              <a:t>6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923B27-632B-97D2-BD0F-9F99375B9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EDEAB6-91EC-98D3-833E-72AED917CD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7F758-F823-3B40-BCD8-0FE5D4CC50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204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CF19C5-098C-9E7B-ACC4-03D9D843AC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3028BA-42E1-E1C4-6FF7-FA86F0FAE1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C77C90-88C3-028B-9B90-BC10FAE17E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669C6B-F08C-B596-F1C5-1B4A82F4A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654E-F97B-134A-8220-F87DA4D60CCC}" type="datetimeFigureOut">
              <a:rPr lang="en-US" smtClean="0"/>
              <a:t>6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7C5690-D85F-CCF5-3C1E-6786348037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0DF1F8-9A67-8F2F-5AE0-95EF4ACBE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7F758-F823-3B40-BCD8-0FE5D4CC50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1368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C5EF347-A39F-2491-2232-64BF738AB4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75D96A-ED96-4717-46A5-CF094A9574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87D8CE-E3B1-DC78-590F-443C76983B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5654E-F97B-134A-8220-F87DA4D60CCC}" type="datetimeFigureOut">
              <a:rPr lang="en-US" smtClean="0"/>
              <a:t>6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83B46F-C48D-216C-8C2D-F274FF731C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563096-2AFB-FF60-8FD5-566707FF07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7F758-F823-3B40-BCD8-0FE5D4CC50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099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mov"/><Relationship Id="rId1" Type="http://schemas.microsoft.com/office/2007/relationships/media" Target="../media/media2.mov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3.mov"/><Relationship Id="rId1" Type="http://schemas.microsoft.com/office/2007/relationships/media" Target="../media/media3.mov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ovie-15 2">
            <a:hlinkClick r:id="" action="ppaction://media"/>
            <a:extLst>
              <a:ext uri="{FF2B5EF4-FFF2-40B4-BE49-F238E27FC236}">
                <a16:creationId xmlns:a16="http://schemas.microsoft.com/office/drawing/2014/main" id="{E1A749A8-5F93-AEB3-BCB3-BD1C453317DF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167186" y="2245110"/>
            <a:ext cx="2556537" cy="236778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BB12BF4-FA1A-C734-6EF1-E143D7F33889}"/>
              </a:ext>
            </a:extLst>
          </p:cNvPr>
          <p:cNvSpPr txBox="1"/>
          <p:nvPr/>
        </p:nvSpPr>
        <p:spPr>
          <a:xfrm>
            <a:off x="616417" y="512868"/>
            <a:ext cx="38149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Supplemental Video S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6BDA456-AC65-D2AD-C59D-99ADEDADC81D}"/>
              </a:ext>
            </a:extLst>
          </p:cNvPr>
          <p:cNvSpPr txBox="1"/>
          <p:nvPr/>
        </p:nvSpPr>
        <p:spPr>
          <a:xfrm>
            <a:off x="4167186" y="1650671"/>
            <a:ext cx="22881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i="1" dirty="0" err="1"/>
              <a:t>Srl</a:t>
            </a:r>
            <a:r>
              <a:rPr lang="en-US" sz="2400" b="1" i="1" baseline="30000" dirty="0" err="1"/>
              <a:t>del</a:t>
            </a:r>
            <a:r>
              <a:rPr lang="en-US" sz="2400" b="1" i="1" baseline="30000" dirty="0"/>
              <a:t>/del</a:t>
            </a:r>
            <a:r>
              <a:rPr lang="en-US" sz="2400" b="1" i="1" dirty="0"/>
              <a:t> embryos</a:t>
            </a:r>
            <a:endParaRPr lang="en-US" sz="2400" b="1" i="1" baseline="30000" dirty="0"/>
          </a:p>
        </p:txBody>
      </p:sp>
    </p:spTree>
    <p:extLst>
      <p:ext uri="{BB962C8B-B14F-4D97-AF65-F5344CB8AC3E}">
        <p14:creationId xmlns:p14="http://schemas.microsoft.com/office/powerpoint/2010/main" val="233742804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302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9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0" fill="hold">
                      <p:stCondLst>
                        <p:cond delay="0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3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4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DC7F88B-715F-B84E-1A27-7C9BA6D7BAD4}"/>
              </a:ext>
            </a:extLst>
          </p:cNvPr>
          <p:cNvSpPr txBox="1"/>
          <p:nvPr/>
        </p:nvSpPr>
        <p:spPr>
          <a:xfrm>
            <a:off x="531298" y="464333"/>
            <a:ext cx="32084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Supplemental Video S2 </a:t>
            </a:r>
          </a:p>
        </p:txBody>
      </p:sp>
      <p:pic>
        <p:nvPicPr>
          <p:cNvPr id="3" name="Movie 1">
            <a:hlinkClick r:id="" action="ppaction://media"/>
            <a:extLst>
              <a:ext uri="{FF2B5EF4-FFF2-40B4-BE49-F238E27FC236}">
                <a16:creationId xmlns:a16="http://schemas.microsoft.com/office/drawing/2014/main" id="{62F7C294-10B7-7958-98F5-0A12C8BF472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079240" y="1412240"/>
            <a:ext cx="4033520" cy="40335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FF9B220-2013-CCBA-A37D-FA9A87F08AF7}"/>
              </a:ext>
            </a:extLst>
          </p:cNvPr>
          <p:cNvSpPr txBox="1"/>
          <p:nvPr/>
        </p:nvSpPr>
        <p:spPr>
          <a:xfrm>
            <a:off x="5425079" y="786691"/>
            <a:ext cx="11285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ontrol</a:t>
            </a:r>
          </a:p>
        </p:txBody>
      </p:sp>
    </p:spTree>
    <p:extLst>
      <p:ext uri="{BB962C8B-B14F-4D97-AF65-F5344CB8AC3E}">
        <p14:creationId xmlns:p14="http://schemas.microsoft.com/office/powerpoint/2010/main" val="77646566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04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Movie 2">
            <a:hlinkClick r:id="" action="ppaction://media"/>
            <a:extLst>
              <a:ext uri="{FF2B5EF4-FFF2-40B4-BE49-F238E27FC236}">
                <a16:creationId xmlns:a16="http://schemas.microsoft.com/office/drawing/2014/main" id="{03C3AC86-4C75-F071-F724-A0A6419FAE4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 flipH="1">
            <a:off x="3720794" y="1740756"/>
            <a:ext cx="4033518" cy="403351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B7EA331-AC30-DD34-8F5B-E2356C0BCD60}"/>
              </a:ext>
            </a:extLst>
          </p:cNvPr>
          <p:cNvSpPr txBox="1"/>
          <p:nvPr/>
        </p:nvSpPr>
        <p:spPr>
          <a:xfrm>
            <a:off x="5158548" y="1214355"/>
            <a:ext cx="73930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i="1" dirty="0" err="1"/>
              <a:t>srl</a:t>
            </a:r>
            <a:r>
              <a:rPr lang="en-US" sz="2800" b="1" i="1" baseline="30000" dirty="0" err="1"/>
              <a:t>IR</a:t>
            </a:r>
            <a:endParaRPr lang="en-US" sz="28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6E93658-58B2-2704-7DD8-914526E87C10}"/>
              </a:ext>
            </a:extLst>
          </p:cNvPr>
          <p:cNvSpPr txBox="1"/>
          <p:nvPr/>
        </p:nvSpPr>
        <p:spPr>
          <a:xfrm>
            <a:off x="534390" y="510639"/>
            <a:ext cx="320363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Supplemental Video</a:t>
            </a:r>
            <a:r>
              <a:rPr lang="en-US" sz="2800" b="1" dirty="0"/>
              <a:t> </a:t>
            </a:r>
            <a:r>
              <a:rPr lang="en-US" sz="2400" b="1" dirty="0"/>
              <a:t>S3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3338320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039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5</Words>
  <Application>Microsoft Office PowerPoint</Application>
  <PresentationFormat>Widescreen</PresentationFormat>
  <Paragraphs>6</Paragraphs>
  <Slides>3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ttaroy, Atanu</dc:creator>
  <cp:lastModifiedBy>Stafford, Hayley</cp:lastModifiedBy>
  <cp:revision>13</cp:revision>
  <dcterms:created xsi:type="dcterms:W3CDTF">2023-01-24T19:37:43Z</dcterms:created>
  <dcterms:modified xsi:type="dcterms:W3CDTF">2023-06-23T16:45:13Z</dcterms:modified>
</cp:coreProperties>
</file>